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581F1C3-9378-479F-9A9D-D5F6758FD8F1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DEE5836-8F12-4847-8F0F-28E1D14166C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288C9C77-C9AD-4A44-8331-6E478CE6210D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02A9F-DCA1-4134-8CCB-07495B41DB6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633B32-9F44-4195-A6E3-D894D0FD64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42310A-4A7A-4122-8C22-0FA7982C61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C45C2-7F34-4C2E-8B4D-BE9AF65DE1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A78EE-C573-4AC3-9B00-FF39F48A873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EA7EE1-9D75-454F-A88C-9997049485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9B643-8188-40CB-826C-321C0722E6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842AF5-75D4-434A-868A-3F4241C46A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CAF76-A5E2-4F22-86DF-F61880804C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132D2-0AF1-40EC-A4BD-FE4D7EC080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1E8A8-B43B-4E8B-A3E6-5A11BD0294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27FD7F-D450-40A2-A14C-832328CD30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555B455-C249-4048-85B0-E4ABF80CA865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25E079C-2083-425E-B258-B1A3BC05EDD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ZoneTexte 32"/>
          <p:cNvSpPr/>
          <p:nvPr/>
        </p:nvSpPr>
        <p:spPr>
          <a:xfrm>
            <a:off x="-1955880" y="2725560"/>
            <a:ext cx="25146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492120" y="662040"/>
            <a:ext cx="8329680" cy="5789520"/>
            <a:chOff x="492120" y="662040"/>
            <a:chExt cx="8329680" cy="5789520"/>
          </a:xfrm>
        </p:grpSpPr>
        <p:grpSp>
          <p:nvGrpSpPr>
            <p:cNvPr id="50" name="Group 26"/>
            <p:cNvGrpSpPr/>
            <p:nvPr/>
          </p:nvGrpSpPr>
          <p:grpSpPr>
            <a:xfrm>
              <a:off x="1949760" y="662040"/>
              <a:ext cx="4911480" cy="4010040"/>
              <a:chOff x="1949760" y="662040"/>
              <a:chExt cx="4911480" cy="4010040"/>
            </a:xfrm>
          </p:grpSpPr>
          <p:pic>
            <p:nvPicPr>
              <p:cNvPr id="51" name="Image 3" descr="Z H77 1A"/>
              <p:cNvPicPr/>
              <p:nvPr/>
            </p:nvPicPr>
            <p:blipFill>
              <a:blip r:embed="rId1"/>
              <a:stretch/>
            </p:blipFill>
            <p:spPr>
              <a:xfrm>
                <a:off x="5558400" y="662040"/>
                <a:ext cx="1302840" cy="130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2" name="Image 4" descr="Z H77 1D"/>
              <p:cNvPicPr/>
              <p:nvPr/>
            </p:nvPicPr>
            <p:blipFill>
              <a:blip r:embed="rId2"/>
              <a:stretch/>
            </p:blipFill>
            <p:spPr>
              <a:xfrm>
                <a:off x="5558400" y="1987560"/>
                <a:ext cx="1302840" cy="130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3" name="Image 5" descr="Z non-inf (- side) 1"/>
              <p:cNvPicPr/>
              <p:nvPr/>
            </p:nvPicPr>
            <p:blipFill>
              <a:blip r:embed="rId3"/>
              <a:stretch/>
            </p:blipFill>
            <p:spPr>
              <a:xfrm>
                <a:off x="5558400" y="3369240"/>
                <a:ext cx="1302840" cy="130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4" name="Image 6" descr="Z H77 isoA"/>
              <p:cNvPicPr/>
              <p:nvPr/>
            </p:nvPicPr>
            <p:blipFill>
              <a:blip r:embed="rId4"/>
              <a:stretch/>
            </p:blipFill>
            <p:spPr>
              <a:xfrm>
                <a:off x="4228560" y="662040"/>
                <a:ext cx="1302840" cy="130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5" name="Image 7" descr="Z H77 isoB"/>
              <p:cNvPicPr/>
              <p:nvPr/>
            </p:nvPicPr>
            <p:blipFill>
              <a:blip r:embed="rId5"/>
              <a:stretch/>
            </p:blipFill>
            <p:spPr>
              <a:xfrm>
                <a:off x="4228560" y="1987560"/>
                <a:ext cx="1302840" cy="130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6" name="Image 8" descr="Z non-inf isoA"/>
              <p:cNvPicPr/>
              <p:nvPr/>
            </p:nvPicPr>
            <p:blipFill>
              <a:blip r:embed="rId6"/>
              <a:stretch/>
            </p:blipFill>
            <p:spPr>
              <a:xfrm>
                <a:off x="4228560" y="3369240"/>
                <a:ext cx="1302840" cy="130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7" name="Image 9" descr="Z H77 2A"/>
              <p:cNvPicPr/>
              <p:nvPr/>
            </p:nvPicPr>
            <p:blipFill>
              <a:blip r:embed="rId7"/>
              <a:stretch/>
            </p:blipFill>
            <p:spPr>
              <a:xfrm>
                <a:off x="2903760" y="662040"/>
                <a:ext cx="1302840" cy="130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8" name="Image 10" descr="Z H77 2B"/>
              <p:cNvPicPr/>
              <p:nvPr/>
            </p:nvPicPr>
            <p:blipFill>
              <a:blip r:embed="rId8"/>
              <a:stretch/>
            </p:blipFill>
            <p:spPr>
              <a:xfrm>
                <a:off x="2903760" y="1987560"/>
                <a:ext cx="1302840" cy="1302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9" name="Image 11" descr="Z non-inf 2B"/>
              <p:cNvPicPr/>
              <p:nvPr/>
            </p:nvPicPr>
            <p:blipFill>
              <a:blip r:embed="rId9"/>
              <a:stretch/>
            </p:blipFill>
            <p:spPr>
              <a:xfrm>
                <a:off x="2903760" y="3369240"/>
                <a:ext cx="1302840" cy="13028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0" name="ZoneTexte 15"/>
              <p:cNvSpPr/>
              <p:nvPr/>
            </p:nvSpPr>
            <p:spPr>
              <a:xfrm>
                <a:off x="1949760" y="3908880"/>
                <a:ext cx="1044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not infect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ZoneTexte 16"/>
              <p:cNvSpPr/>
              <p:nvPr/>
            </p:nvSpPr>
            <p:spPr>
              <a:xfrm>
                <a:off x="2095920" y="1822680"/>
                <a:ext cx="671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HCVw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Accolade ouvrante 17"/>
              <p:cNvSpPr/>
              <p:nvPr/>
            </p:nvSpPr>
            <p:spPr>
              <a:xfrm>
                <a:off x="2698560" y="662040"/>
                <a:ext cx="183960" cy="2621160"/>
              </a:xfrm>
              <a:custGeom>
                <a:avLst/>
                <a:gdLst>
                  <a:gd name="textAreaLeft" fmla="*/ 117720 w 183960"/>
                  <a:gd name="textAreaRight" fmla="*/ 184320 w 183960"/>
                  <a:gd name="textAreaTop" fmla="*/ 19440 h 2621160"/>
                  <a:gd name="textAreaBottom" fmla="*/ 2601720 h 26211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21600" y="0"/>
                    </a:moveTo>
                    <a:cubicBezTo>
                      <a:pt x="16200" y="0"/>
                      <a:pt x="10800" y="257"/>
                      <a:pt x="10800" y="514"/>
                    </a:cubicBezTo>
                    <a:lnTo>
                      <a:pt x="10800" y="10286"/>
                    </a:lnTo>
                    <a:cubicBezTo>
                      <a:pt x="10800" y="10543"/>
                      <a:pt x="5400" y="10800"/>
                      <a:pt x="0" y="10800"/>
                    </a:cubicBezTo>
                    <a:cubicBezTo>
                      <a:pt x="5400" y="10800"/>
                      <a:pt x="10800" y="11057"/>
                      <a:pt x="10800" y="11314"/>
                    </a:cubicBezTo>
                    <a:lnTo>
                      <a:pt x="10800" y="21086"/>
                    </a:lnTo>
                    <a:cubicBezTo>
                      <a:pt x="10800" y="21343"/>
                      <a:pt x="16200" y="21600"/>
                      <a:pt x="21600" y="2160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ZoneTexte 18"/>
              <p:cNvSpPr/>
              <p:nvPr/>
            </p:nvSpPr>
            <p:spPr>
              <a:xfrm>
                <a:off x="3673800" y="1525680"/>
                <a:ext cx="49608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92d050"/>
                    </a:solidFill>
                    <a:latin typeface="Arial"/>
                    <a:ea typeface="Arial"/>
                  </a:rPr>
                  <a:t>Fab’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Ig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ZoneTexte 23"/>
              <p:cNvSpPr/>
              <p:nvPr/>
            </p:nvSpPr>
            <p:spPr>
              <a:xfrm>
                <a:off x="6385320" y="4240440"/>
                <a:ext cx="44748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92d050"/>
                    </a:solidFill>
                    <a:latin typeface="Arial"/>
                    <a:ea typeface="Arial"/>
                  </a:rPr>
                  <a:t>HCV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A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ZoneTexte 24"/>
              <p:cNvSpPr/>
              <p:nvPr/>
            </p:nvSpPr>
            <p:spPr>
              <a:xfrm>
                <a:off x="6385320" y="2851200"/>
                <a:ext cx="44748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92d050"/>
                    </a:solidFill>
                    <a:latin typeface="Arial"/>
                    <a:ea typeface="Arial"/>
                  </a:rPr>
                  <a:t>HCV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A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ZoneTexte 26"/>
              <p:cNvSpPr/>
              <p:nvPr/>
            </p:nvSpPr>
            <p:spPr>
              <a:xfrm>
                <a:off x="6385320" y="1525680"/>
                <a:ext cx="44748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92d050"/>
                    </a:solidFill>
                    <a:latin typeface="Arial"/>
                    <a:ea typeface="Arial"/>
                  </a:rPr>
                  <a:t>HCV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mA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ZoneTexte 27"/>
              <p:cNvSpPr/>
              <p:nvPr/>
            </p:nvSpPr>
            <p:spPr>
              <a:xfrm>
                <a:off x="4913640" y="1525680"/>
                <a:ext cx="58140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92d050"/>
                    </a:solidFill>
                    <a:latin typeface="Arial"/>
                    <a:ea typeface="Arial"/>
                  </a:rPr>
                  <a:t>norm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isotyp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ZoneTexte 28"/>
              <p:cNvSpPr/>
              <p:nvPr/>
            </p:nvSpPr>
            <p:spPr>
              <a:xfrm>
                <a:off x="4913640" y="4240440"/>
                <a:ext cx="58140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92d050"/>
                    </a:solidFill>
                    <a:latin typeface="Arial"/>
                    <a:ea typeface="Arial"/>
                  </a:rPr>
                  <a:t>norm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isotyp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ZoneTexte 29"/>
              <p:cNvSpPr/>
              <p:nvPr/>
            </p:nvSpPr>
            <p:spPr>
              <a:xfrm>
                <a:off x="4913640" y="2851200"/>
                <a:ext cx="58140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92d050"/>
                    </a:solidFill>
                    <a:latin typeface="Arial"/>
                    <a:ea typeface="Arial"/>
                  </a:rPr>
                  <a:t>normal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isotype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ZoneTexte 30"/>
              <p:cNvSpPr/>
              <p:nvPr/>
            </p:nvSpPr>
            <p:spPr>
              <a:xfrm>
                <a:off x="3673800" y="4240440"/>
                <a:ext cx="49608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92d050"/>
                    </a:solidFill>
                    <a:latin typeface="Arial"/>
                    <a:ea typeface="Arial"/>
                  </a:rPr>
                  <a:t>Fab’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Ig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ZoneTexte 31"/>
              <p:cNvSpPr/>
              <p:nvPr/>
            </p:nvSpPr>
            <p:spPr>
              <a:xfrm>
                <a:off x="3673800" y="2851200"/>
                <a:ext cx="49608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92d050"/>
                    </a:solidFill>
                    <a:latin typeface="Arial"/>
                    <a:ea typeface="Arial"/>
                  </a:rPr>
                  <a:t>Fab’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ff0000"/>
                    </a:solidFill>
                    <a:latin typeface="Arial"/>
                    <a:ea typeface="Arial"/>
                  </a:rPr>
                  <a:t>IgG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" name="Rectangle 95"/>
            <p:cNvSpPr/>
            <p:nvPr/>
          </p:nvSpPr>
          <p:spPr>
            <a:xfrm>
              <a:off x="492120" y="4897440"/>
              <a:ext cx="8329680" cy="155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just">
                <a:spcAft>
                  <a:spcPts val="1800"/>
                </a:spcAft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igure S6. </a:t>
              </a: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Ex vivo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nfection of normal human liver slices by HCVwt.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lices were cut from normal human liver sample (sections from the remaining fragment of a liver that had been successfully grafted) and were incubated </a:t>
              </a: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ex vivo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with or without HCVwt, then kept in culture medium for 7 days. After fixation and permeabilization, the slices were incubated with: anti-human IgG Fab’2 plus anti-mouse IgG1 antibodies (left panels); control normal human serum plus mouse IgG1 isotype, then secondary antibodies (center panels); human serum from a genotype 1a-cured patient plus anti-HCV1a structural genes mouse IgG1, then secondary antibodies (right panels). Slices were counterstained with Hoechst 33342 and analyzed with bi-photon confocal microscopy; Z-stacks of blue, green and red channels were overlayed.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8T07:00:19Z</dcterms:created>
  <dc:creator>bertrand saunier</dc:creator>
  <dc:description/>
  <dc:language>en-US</dc:language>
  <cp:lastModifiedBy>triyatnm</cp:lastModifiedBy>
  <dcterms:modified xsi:type="dcterms:W3CDTF">2011-03-09T18:32:07Z</dcterms:modified>
  <cp:revision>138</cp:revision>
  <dc:subject/>
  <dc:title>Slide 1</dc:title>
</cp:coreProperties>
</file>